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14400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B91650-8382-417E-B044-8C2564242282}" v="1" dt="2021-10-08T10:47:05.88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g Ho" userId="3459b55388f68bf5" providerId="LiveId" clId="{39B91650-8382-417E-B044-8C2564242282}"/>
    <pc:docChg chg="custSel modSld">
      <pc:chgData name="Kang Ho" userId="3459b55388f68bf5" providerId="LiveId" clId="{39B91650-8382-417E-B044-8C2564242282}" dt="2021-10-08T10:48:12.766" v="65" actId="1037"/>
      <pc:docMkLst>
        <pc:docMk/>
      </pc:docMkLst>
      <pc:sldChg chg="addSp delSp modSp mod">
        <pc:chgData name="Kang Ho" userId="3459b55388f68bf5" providerId="LiveId" clId="{39B91650-8382-417E-B044-8C2564242282}" dt="2021-10-08T10:48:12.766" v="65" actId="1037"/>
        <pc:sldMkLst>
          <pc:docMk/>
          <pc:sldMk cId="154026588" sldId="256"/>
        </pc:sldMkLst>
        <pc:spChg chg="add mod">
          <ac:chgData name="Kang Ho" userId="3459b55388f68bf5" providerId="LiveId" clId="{39B91650-8382-417E-B044-8C2564242282}" dt="2021-10-08T10:48:12.766" v="65" actId="1037"/>
          <ac:spMkLst>
            <pc:docMk/>
            <pc:sldMk cId="154026588" sldId="256"/>
            <ac:spMk id="6" creationId="{9761DBC1-48DB-4F6A-BF5D-0FD6E98B5B02}"/>
          </ac:spMkLst>
        </pc:spChg>
        <pc:spChg chg="add del">
          <ac:chgData name="Kang Ho" userId="3459b55388f68bf5" providerId="LiveId" clId="{39B91650-8382-417E-B044-8C2564242282}" dt="2021-10-08T10:47:47.937" v="34" actId="478"/>
          <ac:spMkLst>
            <pc:docMk/>
            <pc:sldMk cId="154026588" sldId="256"/>
            <ac:spMk id="8" creationId="{D44C9624-D176-4F2A-B4B8-6017867F30BB}"/>
          </ac:spMkLst>
        </pc:spChg>
        <pc:graphicFrameChg chg="add del mod">
          <ac:chgData name="Kang Ho" userId="3459b55388f68bf5" providerId="LiveId" clId="{39B91650-8382-417E-B044-8C2564242282}" dt="2021-10-08T10:47:14.935" v="2" actId="478"/>
          <ac:graphicFrameMkLst>
            <pc:docMk/>
            <pc:sldMk cId="154026588" sldId="256"/>
            <ac:graphicFrameMk id="2" creationId="{B0D9C227-4C72-47CE-B3CD-481EF16202E4}"/>
          </ac:graphicFrameMkLst>
        </pc:graphicFrameChg>
        <pc:picChg chg="mod">
          <ac:chgData name="Kang Ho" userId="3459b55388f68bf5" providerId="LiveId" clId="{39B91650-8382-417E-B044-8C2564242282}" dt="2021-10-08T10:47:18.537" v="28" actId="1036"/>
          <ac:picMkLst>
            <pc:docMk/>
            <pc:sldMk cId="154026588" sldId="256"/>
            <ac:picMk id="4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E3496A-EB31-4A89-83B3-0540F8F4696F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B86413-1E34-4688-B9C2-A06453498D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218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1pPr>
    <a:lvl2pPr marL="822869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2pPr>
    <a:lvl3pPr marL="1645737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3pPr>
    <a:lvl4pPr marL="2468606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4pPr>
    <a:lvl5pPr marL="3291474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5pPr>
    <a:lvl6pPr marL="4114343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6pPr>
    <a:lvl7pPr marL="4937211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7pPr>
    <a:lvl8pPr marL="5760080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8pPr>
    <a:lvl9pPr marL="6582948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DAB6A7-48F8-4F7F-A6C8-4DEE71ED1A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9482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620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5685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181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067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433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740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997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1318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0540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284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519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1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1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1917" y="2669177"/>
            <a:ext cx="9913281" cy="9442066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225653" y="13107707"/>
            <a:ext cx="139522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2400" baseline="0" dirty="0">
                <a:latin typeface="Arial" panose="020B0604020202020204" pitchFamily="34" charset="0"/>
                <a:cs typeface="Arial" panose="020B0604020202020204" pitchFamily="34" charset="0"/>
              </a:rPr>
              <a:t> Figure 1. Correlation between ACP and PCP in label-free quantification datase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61DBC1-48DB-4F6A-BF5D-0FD6E98B5B02}"/>
              </a:ext>
            </a:extLst>
          </p:cNvPr>
          <p:cNvSpPr txBox="1"/>
          <p:nvPr/>
        </p:nvSpPr>
        <p:spPr>
          <a:xfrm>
            <a:off x="324752" y="453803"/>
            <a:ext cx="137417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itl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n-depth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fili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ap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btype-specif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raniopharyngioma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Jung Hee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y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is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eong-Ik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Park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ohyu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Yo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wy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</a:p>
          <a:p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026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9</Words>
  <Application>Microsoft Office PowerPoint</Application>
  <PresentationFormat>사용자 지정</PresentationFormat>
  <Paragraphs>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ng Ho</dc:creator>
  <cp:lastModifiedBy>Kang Ho</cp:lastModifiedBy>
  <cp:revision>5</cp:revision>
  <dcterms:created xsi:type="dcterms:W3CDTF">2021-03-10T03:54:49Z</dcterms:created>
  <dcterms:modified xsi:type="dcterms:W3CDTF">2021-10-08T10:48:16Z</dcterms:modified>
</cp:coreProperties>
</file>